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872" y="-120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846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840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795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988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816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103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959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348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860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312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88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67719-6600-45F4-838A-9F790A50AD45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44633-C349-4D10-966D-ABCE161F0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787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7204109"/>
              </p:ext>
            </p:extLst>
          </p:nvPr>
        </p:nvGraphicFramePr>
        <p:xfrm>
          <a:off x="1556147" y="1268760"/>
          <a:ext cx="6013450" cy="3600400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3133090"/>
                <a:gridCol w="1494790"/>
                <a:gridCol w="1385570"/>
              </a:tblGrid>
              <a:tr h="753042">
                <a:tc>
                  <a:txBody>
                    <a:bodyPr/>
                    <a:lstStyle/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 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T2D patient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ontrol individual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7358">
                <a:tc>
                  <a:txBody>
                    <a:bodyPr/>
                    <a:lstStyle/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 (men/ women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ge (years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ge at diagnostic (years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GB" sz="1100" baseline="300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bA1c (%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DL-cholesterol (</a:t>
                      </a: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mol</a:t>
                      </a: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/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total cholesterol (</a:t>
                      </a: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mol</a:t>
                      </a: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/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total cholesterol/HDL- cholesterol (</a:t>
                      </a: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mol</a:t>
                      </a: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/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triacylglycerol (</a:t>
                      </a: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mol</a:t>
                      </a: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/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fasting blood glucose (</a:t>
                      </a: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mol</a:t>
                      </a: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/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ypoglycaemic treatment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99 (189/110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69.2 ± 10.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0.1 ± 11.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9.5 ± 5.8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8.4 ± 2.0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1 ± 0.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.4 ± 1.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.4 ± 3.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.2 ± 1.8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.6 ± 1.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ye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52 (238/114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5.6 ± 7.4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a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8.5 ± 3.6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.1 ± 0.7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4 ± 0.4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.6 ± 0.9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.1 ± 1.5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8 ± 1.3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.4 ± 0.5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180340" marR="8826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o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1484784" y="620688"/>
            <a:ext cx="615617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Table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haracteristics of the T2D and control groups from the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Laus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cohort, </a:t>
            </a:r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alysed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to establish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distribution of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GJD2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SNP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547664" y="5061084"/>
            <a:ext cx="604867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ata are expressed as mean ± SD of the indicated number (n) of individuals. BMI = body mass index; HbA1c = glycosylated haemoglobin A1c; HDL = high-density lipoproteins;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= not applicable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9649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73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7</cp:revision>
  <dcterms:created xsi:type="dcterms:W3CDTF">2015-03-29T16:40:53Z</dcterms:created>
  <dcterms:modified xsi:type="dcterms:W3CDTF">2015-11-15T13:52:42Z</dcterms:modified>
</cp:coreProperties>
</file>